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9" d="100"/>
          <a:sy n="49" d="100"/>
        </p:scale>
        <p:origin x="233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246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518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62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425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000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80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87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594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552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238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72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537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>
            <a:extLst>
              <a:ext uri="{FF2B5EF4-FFF2-40B4-BE49-F238E27FC236}">
                <a16:creationId xmlns="" xmlns:a16="http://schemas.microsoft.com/office/drawing/2014/main" id="{6455A3E0-16EC-4B0C-B3F0-CBC960928A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091141"/>
              </p:ext>
            </p:extLst>
          </p:nvPr>
        </p:nvGraphicFramePr>
        <p:xfrm>
          <a:off x="0" y="822325"/>
          <a:ext cx="3548063" cy="301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3" imgW="3547697" imgH="3015930" progId="Prism8.Document">
                  <p:embed/>
                </p:oleObj>
              </mc:Choice>
              <mc:Fallback>
                <p:oleObj name="Prism 8" r:id="rId3" imgW="3547697" imgH="3015930" progId="Prism8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="" xmlns:a16="http://schemas.microsoft.com/office/drawing/2014/main" id="{6455A3E0-16EC-4B0C-B3F0-CBC960928A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822325"/>
                        <a:ext cx="3548063" cy="301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本框 6">
            <a:extLst>
              <a:ext uri="{FF2B5EF4-FFF2-40B4-BE49-F238E27FC236}">
                <a16:creationId xmlns="" xmlns:a16="http://schemas.microsoft.com/office/drawing/2014/main" id="{7AFA7C4F-E182-4B92-8C4D-919C40D3355F}"/>
              </a:ext>
            </a:extLst>
          </p:cNvPr>
          <p:cNvSpPr txBox="1"/>
          <p:nvPr/>
        </p:nvSpPr>
        <p:spPr>
          <a:xfrm>
            <a:off x="54692" y="119132"/>
            <a:ext cx="34933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76BA52A5-A853-4EB7-B7F5-724ADD88CB21}"/>
              </a:ext>
            </a:extLst>
          </p:cNvPr>
          <p:cNvSpPr txBox="1"/>
          <p:nvPr/>
        </p:nvSpPr>
        <p:spPr>
          <a:xfrm>
            <a:off x="54692" y="4140394"/>
            <a:ext cx="6701708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 </a:t>
            </a:r>
            <a:r>
              <a:rPr lang="en-GB" altLang="zh-CN" sz="1800" b="1" dirty="0" smtClean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</a:t>
            </a:r>
            <a:r>
              <a:rPr lang="en-US" altLang="zh-CN" sz="1800" b="1" dirty="0" smtClean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</a:t>
            </a:r>
            <a:r>
              <a:rPr lang="en-GB" altLang="zh-CN" sz="1800" b="1" dirty="0" smtClean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GB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activity of GBP5 protein assay developed with the </a:t>
            </a:r>
            <a:r>
              <a:rPr lang="en-GB" altLang="zh-CN" sz="1800" b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b</a:t>
            </a:r>
            <a:r>
              <a:rPr lang="en-GB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air of 7G9 and 9A9. 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293T cells transfected with the GBP5 expression plasmid were lysed with </a:t>
            </a:r>
            <a:r>
              <a:rPr lang="en-GB" altLang="zh-CN" sz="1800" kern="0" dirty="0">
                <a:effectLst/>
                <a:latin typeface="Times New Roman" panose="02020603050405020304" pitchFamily="18" charset="0"/>
                <a:ea typeface="MinionPro-Regular"/>
              </a:rPr>
              <a:t>lysis buffer</a:t>
            </a:r>
            <a:r>
              <a:rPr lang="en-GB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as a positive sample, using lysed mock-infected 293T cells as a negative sample. The OD value of the positive sample was more than 40 times higher than that of the negative sample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35039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6</TotalTime>
  <Words>74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Arial</vt:lpstr>
      <vt:lpstr>Calibri</vt:lpstr>
      <vt:lpstr>Calibri Light</vt:lpstr>
      <vt:lpstr>等线</vt:lpstr>
      <vt:lpstr>等线 Light</vt:lpstr>
      <vt:lpstr>MinionPro-Regular</vt:lpstr>
      <vt:lpstr>Times New Roman</vt:lpstr>
      <vt:lpstr>Office 主题​​</vt:lpstr>
      <vt:lpstr>Prism 8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伟 刘</dc:creator>
  <cp:lastModifiedBy>Indhumathi</cp:lastModifiedBy>
  <cp:revision>11</cp:revision>
  <dcterms:created xsi:type="dcterms:W3CDTF">2021-01-28T00:09:42Z</dcterms:created>
  <dcterms:modified xsi:type="dcterms:W3CDTF">2022-03-29T06:02:59Z</dcterms:modified>
</cp:coreProperties>
</file>